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보통 스타일 2 - 강조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2994" y="6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5895C1-E683-467D-B831-55EA236273D9}" type="datetimeFigureOut">
              <a:rPr lang="ko-KR" altLang="en-US" smtClean="0"/>
              <a:t>2018-09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0FE57E-935D-4C0A-BE7B-82EA90E720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80502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0FE57E-935D-4C0A-BE7B-82EA90E720DB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77420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8.jpeg"/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12" Type="http://schemas.microsoft.com/office/2007/relationships/hdphoto" Target="../media/hdphoto3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openxmlformats.org/officeDocument/2006/relationships/image" Target="../media/image3.jpeg"/><Relationship Id="rId15" Type="http://schemas.openxmlformats.org/officeDocument/2006/relationships/image" Target="../media/image10.png"/><Relationship Id="rId10" Type="http://schemas.microsoft.com/office/2007/relationships/hdphoto" Target="../media/hdphoto2.wdp"/><Relationship Id="rId4" Type="http://schemas.openxmlformats.org/officeDocument/2006/relationships/image" Target="../media/image2.jpeg"/><Relationship Id="rId9" Type="http://schemas.openxmlformats.org/officeDocument/2006/relationships/image" Target="../media/image6.png"/><Relationship Id="rId1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841203" y="220616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841203" y="426637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8829048">
            <a:off x="3110664" y="2757490"/>
            <a:ext cx="658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-NC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8829048">
            <a:off x="3506213" y="2650512"/>
            <a:ext cx="939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-</a:t>
            </a:r>
            <a:r>
              <a:rPr lang="en-US" altLang="ko-K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TGF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β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1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8829048">
            <a:off x="3976299" y="2680810"/>
            <a:ext cx="8556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d-</a:t>
            </a:r>
            <a:r>
              <a:rPr lang="en-US" altLang="ko-K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hTGF</a:t>
            </a:r>
            <a:r>
              <a:rPr lang="el-GR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463357" y="3161852"/>
            <a:ext cx="637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p38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590765" y="3645301"/>
            <a:ext cx="637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x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420888" y="3902994"/>
            <a:ext cx="7219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8" descr="C:\Users\cshan1129\Desktop\그림3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0719" y="3133302"/>
            <a:ext cx="1426393" cy="23208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9" descr="C:\Users\cshan1129\Desktop\그림4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0719" y="3659408"/>
            <a:ext cx="1426393" cy="20351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0" descr="C:\Users\cshan1129\Desktop\그림5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0719" y="3893797"/>
            <a:ext cx="1426393" cy="21677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2548296" y="3417722"/>
            <a:ext cx="637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Picture 3" descr="C:\Users\cshan1129\Desktop\그림1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0718" y="3397005"/>
            <a:ext cx="1426394" cy="23208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" name="그룹 1"/>
          <p:cNvGrpSpPr/>
          <p:nvPr/>
        </p:nvGrpSpPr>
        <p:grpSpPr>
          <a:xfrm>
            <a:off x="2420888" y="4415949"/>
            <a:ext cx="2620707" cy="1452195"/>
            <a:chOff x="582611" y="661171"/>
            <a:chExt cx="7183380" cy="3870370"/>
          </a:xfrm>
        </p:grpSpPr>
        <p:pic>
          <p:nvPicPr>
            <p:cNvPr id="21" name="그림 20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00" t="25973" r="47101" b="64816"/>
            <a:stretch/>
          </p:blipFill>
          <p:spPr>
            <a:xfrm>
              <a:off x="2383325" y="2578049"/>
              <a:ext cx="1554481" cy="569753"/>
            </a:xfrm>
            <a:prstGeom prst="rect">
              <a:avLst/>
            </a:prstGeom>
          </p:spPr>
        </p:pic>
        <p:pic>
          <p:nvPicPr>
            <p:cNvPr id="22" name="그림 21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382" t="75866" r="39864" b="14775"/>
            <a:stretch/>
          </p:blipFill>
          <p:spPr>
            <a:xfrm>
              <a:off x="2383325" y="1862051"/>
              <a:ext cx="1554481" cy="641836"/>
            </a:xfrm>
            <a:prstGeom prst="rect">
              <a:avLst/>
            </a:prstGeom>
          </p:spPr>
        </p:pic>
        <p:pic>
          <p:nvPicPr>
            <p:cNvPr id="23" name="그림 22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543" t="75883" r="19297" b="14775"/>
            <a:stretch/>
          </p:blipFill>
          <p:spPr>
            <a:xfrm>
              <a:off x="4183582" y="1862051"/>
              <a:ext cx="1602223" cy="641836"/>
            </a:xfrm>
            <a:prstGeom prst="rect">
              <a:avLst/>
            </a:prstGeom>
          </p:spPr>
        </p:pic>
        <p:pic>
          <p:nvPicPr>
            <p:cNvPr id="24" name="그림 23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455" t="22597" r="32359" b="67492"/>
            <a:stretch/>
          </p:blipFill>
          <p:spPr>
            <a:xfrm>
              <a:off x="4183582" y="2554067"/>
              <a:ext cx="1602223" cy="593735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2552864" y="3156286"/>
              <a:ext cx="1384941" cy="574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P: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rx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292446" y="3177349"/>
              <a:ext cx="1402517" cy="574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P: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x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82611" y="1943229"/>
              <a:ext cx="1894626" cy="574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B: ASK1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" name="그림 27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84" t="70989" r="68489" b="20280"/>
            <a:stretch/>
          </p:blipFill>
          <p:spPr>
            <a:xfrm>
              <a:off x="2383326" y="3932731"/>
              <a:ext cx="1614140" cy="598810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624003" y="3938587"/>
              <a:ext cx="1894626" cy="574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B: ASK1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79986" y="2603103"/>
              <a:ext cx="1582664" cy="574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B: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rx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826383" y="1930191"/>
              <a:ext cx="1894626" cy="574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B: ASK1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871365" y="3932215"/>
              <a:ext cx="1894626" cy="574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B: ASK1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863986" y="2569399"/>
              <a:ext cx="1600239" cy="574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B: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x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8661024">
              <a:off x="2295819" y="1161846"/>
              <a:ext cx="1209914" cy="590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18661024">
              <a:off x="2973482" y="1101160"/>
              <a:ext cx="1419259" cy="590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8661024">
              <a:off x="4155631" y="1136223"/>
              <a:ext cx="1209914" cy="590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8661024">
              <a:off x="4833289" y="1075534"/>
              <a:ext cx="1419259" cy="590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ko-KR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8" name="그림 37"/>
            <p:cNvPicPr>
              <a:picLocks noChangeAspect="1"/>
            </p:cNvPicPr>
            <p:nvPr/>
          </p:nvPicPr>
          <p:blipFill rotWithShape="1">
            <a:blip r:embed="rId15"/>
            <a:srcRect l="22208" t="72157" r="13432" b="2356"/>
            <a:stretch/>
          </p:blipFill>
          <p:spPr>
            <a:xfrm>
              <a:off x="4163334" y="3932731"/>
              <a:ext cx="1622471" cy="573725"/>
            </a:xfrm>
            <a:prstGeom prst="rect">
              <a:avLst/>
            </a:prstGeom>
          </p:spPr>
        </p:pic>
      </p:grpSp>
      <p:sp>
        <p:nvSpPr>
          <p:cNvPr id="39" name="TextBox 38"/>
          <p:cNvSpPr txBox="1"/>
          <p:nvPr/>
        </p:nvSpPr>
        <p:spPr>
          <a:xfrm>
            <a:off x="188640" y="323528"/>
            <a:ext cx="1346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. Fig. 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8368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8</TotalTime>
  <Words>47</Words>
  <Application>Microsoft Office PowerPoint</Application>
  <PresentationFormat>화면 슬라이드 쇼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severan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js109</dc:creator>
  <cp:lastModifiedBy>송재진(의생명과학부)</cp:lastModifiedBy>
  <cp:revision>86</cp:revision>
  <cp:lastPrinted>2018-06-01T07:55:06Z</cp:lastPrinted>
  <dcterms:created xsi:type="dcterms:W3CDTF">2017-09-09T11:44:52Z</dcterms:created>
  <dcterms:modified xsi:type="dcterms:W3CDTF">2018-09-07T03:21:58Z</dcterms:modified>
</cp:coreProperties>
</file>